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jpeg" ContentType="image/jpeg"/>
  <Override PartName="/ppt/media/image3.png" ContentType="image/png"/>
  <Override PartName="/ppt/media/image4.jpeg" ContentType="image/jpeg"/>
  <Override PartName="/ppt/media/image5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90BFEA-15A7-49E6-8113-73FFDC22A1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B36C1C-ABE4-4ED9-B173-E08A382BDF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7058B4-40C9-4F1C-B288-D96C158042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F5ACA4-4DF5-4978-B90A-4D2C4F613A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5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518EBA-FA4B-4268-9729-E63CA236592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94FCF2F-7A59-47F3-943E-DB987A74F4F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36DF2B-3E12-41FD-BCAB-603C599777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E8B2D2-F969-4172-B9CC-EC6DBA3A8E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E18E9D-252D-442A-BA97-402109D17AD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818A62-DE89-49E7-9A30-3651244B4E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4968BC-B9EA-472C-B507-B3AD83BCC21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indent="0">
              <a:spcBef>
                <a:spcPts val="85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E90BB-B041-4268-BD72-04D867A98C1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7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7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t">
            <a:normAutofit/>
          </a:bodyPr>
          <a:p>
            <a:pPr marL="365040" indent="-36504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1" marL="793800" indent="-30492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2" marL="1220760" indent="-243000">
              <a:spcBef>
                <a:spcPts val="850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3" marL="1709640" indent="-242640">
              <a:spcBef>
                <a:spcPts val="850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4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5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  <a:p>
            <a:pPr lvl="6" marL="2197080" indent="-243000">
              <a:spcBef>
                <a:spcPts val="850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4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3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0000"/>
            <a:ext cx="217152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0000"/>
            <a:ext cx="1600200" cy="528840"/>
          </a:xfrm>
          <a:prstGeom prst="rect">
            <a:avLst/>
          </a:prstGeom>
          <a:noFill/>
          <a:ln w="0">
            <a:noFill/>
          </a:ln>
        </p:spPr>
        <p:txBody>
          <a:bodyPr lIns="97560" rIns="97560" tIns="48960" bIns="4896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3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19E8BE6-75D8-4762-AE58-1E3CBF575DC3}" type="slidenum">
              <a:rPr b="0" lang="fr-FR" sz="13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3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4.jpeg"/><Relationship Id="rId5" Type="http://schemas.openxmlformats.org/officeDocument/2006/relationships/image" Target="../media/image5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7" descr=""/>
          <p:cNvPicPr/>
          <p:nvPr/>
        </p:nvPicPr>
        <p:blipFill>
          <a:blip r:embed="rId1"/>
          <a:stretch/>
        </p:blipFill>
        <p:spPr>
          <a:xfrm>
            <a:off x="5340240" y="1469880"/>
            <a:ext cx="287280" cy="2181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Image 2" descr=""/>
          <p:cNvPicPr/>
          <p:nvPr/>
        </p:nvPicPr>
        <p:blipFill>
          <a:blip r:embed="rId2"/>
          <a:srcRect l="2469" t="2634" r="2594" b="37544"/>
          <a:stretch/>
        </p:blipFill>
        <p:spPr>
          <a:xfrm>
            <a:off x="368280" y="1677960"/>
            <a:ext cx="3344760" cy="1754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graphicFrame>
        <p:nvGraphicFramePr>
          <p:cNvPr id="43" name=""/>
          <p:cNvGraphicFramePr/>
          <p:nvPr/>
        </p:nvGraphicFramePr>
        <p:xfrm>
          <a:off x="353880" y="684360"/>
          <a:ext cx="6191280" cy="590400"/>
        </p:xfrm>
        <a:graphic>
          <a:graphicData uri="http://schemas.openxmlformats.org/drawingml/2006/table">
            <a:tbl>
              <a:tblPr/>
              <a:tblGrid>
                <a:gridCol w="1301760"/>
                <a:gridCol w="1752840"/>
                <a:gridCol w="1751040"/>
                <a:gridCol w="685800"/>
                <a:gridCol w="699840"/>
              </a:tblGrid>
              <a:tr h="328320"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System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 forward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Primer rever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Expected Tm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ffffff"/>
                          </a:solidFill>
                          <a:latin typeface="Calibri"/>
                        </a:rPr>
                        <a:t>Expected siz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18720">
                      <a:solidFill>
                        <a:srgbClr val="ffffff"/>
                      </a:solidFill>
                    </a:lnB>
                    <a:solidFill>
                      <a:srgbClr val="000000"/>
                    </a:solidFill>
                  </a:tcPr>
                </a:tc>
              </a:tr>
              <a:tr h="262080"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 </a:t>
                      </a: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1601901-HERV0116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AGACCAATGCAGTTAGGTG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GGCTGCAAGAAATGC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0.5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  <a:tc>
                  <a:txBody>
                    <a:bodyPr lIns="97920" rIns="97920" tIns="42480" bIns="4248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0 pb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97920" marR="9792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1872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solidFill>
                      <a:srgbClr val="cbcbcb"/>
                    </a:solidFill>
                  </a:tcPr>
                </a:tc>
              </a:tr>
            </a:tbl>
          </a:graphicData>
        </a:graphic>
      </p:graphicFrame>
      <p:pic>
        <p:nvPicPr>
          <p:cNvPr id="44" name="Picture 6" descr=""/>
          <p:cNvPicPr/>
          <p:nvPr/>
        </p:nvPicPr>
        <p:blipFill>
          <a:blip r:embed="rId3"/>
          <a:srcRect l="0" t="0" r="50008" b="0"/>
          <a:stretch/>
        </p:blipFill>
        <p:spPr>
          <a:xfrm>
            <a:off x="4811760" y="1469880"/>
            <a:ext cx="504720" cy="2181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5" name="ZoneTexte 17"/>
          <p:cNvSpPr/>
          <p:nvPr/>
        </p:nvSpPr>
        <p:spPr>
          <a:xfrm>
            <a:off x="5945040" y="2852640"/>
            <a:ext cx="6526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100" spc="-1" strike="noStrike">
                <a:solidFill>
                  <a:srgbClr val="000000"/>
                </a:solidFill>
                <a:latin typeface="Calibri"/>
                <a:ea typeface="Arial"/>
              </a:rPr>
              <a:t>157 pb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6" name="Image 1" descr=""/>
          <p:cNvPicPr/>
          <p:nvPr/>
        </p:nvPicPr>
        <p:blipFill>
          <a:blip r:embed="rId4"/>
          <a:srcRect l="4018" t="7419" r="4137" b="35110"/>
          <a:stretch/>
        </p:blipFill>
        <p:spPr>
          <a:xfrm>
            <a:off x="353880" y="1677960"/>
            <a:ext cx="1944720" cy="99072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47" name="Rectangle 22"/>
          <p:cNvSpPr/>
          <p:nvPr/>
        </p:nvSpPr>
        <p:spPr>
          <a:xfrm>
            <a:off x="366840" y="1677960"/>
            <a:ext cx="787320" cy="390600"/>
          </a:xfrm>
          <a:prstGeom prst="rect">
            <a:avLst/>
          </a:prstGeom>
          <a:solidFill>
            <a:srgbClr val="000000"/>
          </a:solidFill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Calibri"/>
              </a:rPr>
              <a:t>56°C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900" spc="-1" strike="noStrike">
                <a:solidFill>
                  <a:srgbClr val="ffffff"/>
                </a:solidFill>
                <a:latin typeface="Calibri"/>
              </a:rPr>
              <a:t>gDNA: 1 ng </a:t>
            </a:r>
            <a:endParaRPr b="0" lang="en-US" sz="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Rectangle 27"/>
          <p:cNvSpPr/>
          <p:nvPr/>
        </p:nvSpPr>
        <p:spPr>
          <a:xfrm>
            <a:off x="163440" y="250920"/>
            <a:ext cx="6573960" cy="938196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ZoneTexte 5"/>
          <p:cNvSpPr/>
          <p:nvPr/>
        </p:nvSpPr>
        <p:spPr>
          <a:xfrm>
            <a:off x="182520" y="382680"/>
            <a:ext cx="32400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ZoneTexte 5"/>
          <p:cNvSpPr/>
          <p:nvPr/>
        </p:nvSpPr>
        <p:spPr>
          <a:xfrm>
            <a:off x="169920" y="134928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ZoneTexte 5"/>
          <p:cNvSpPr/>
          <p:nvPr/>
        </p:nvSpPr>
        <p:spPr>
          <a:xfrm>
            <a:off x="4351320" y="1417680"/>
            <a:ext cx="32400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ZoneTexte 5"/>
          <p:cNvSpPr/>
          <p:nvPr/>
        </p:nvSpPr>
        <p:spPr>
          <a:xfrm>
            <a:off x="173160" y="354348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D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3" name="Connecteur droit avec flèche 3"/>
          <p:cNvCxnSpPr/>
          <p:nvPr/>
        </p:nvCxnSpPr>
        <p:spPr>
          <a:xfrm flipH="1">
            <a:off x="5648040" y="2982600"/>
            <a:ext cx="329040" cy="1080"/>
          </a:xfrm>
          <a:prstGeom prst="straightConnector1">
            <a:avLst/>
          </a:prstGeom>
          <a:ln w="19080">
            <a:solidFill>
              <a:srgbClr val="000000"/>
            </a:solidFill>
            <a:miter/>
            <a:tailEnd len="med" type="arrow" w="med"/>
          </a:ln>
        </p:spPr>
      </p:cxnSp>
      <p:pic>
        <p:nvPicPr>
          <p:cNvPr id="54" name="Picture 31" descr=""/>
          <p:cNvPicPr/>
          <p:nvPr/>
        </p:nvPicPr>
        <p:blipFill>
          <a:blip r:embed="rId5"/>
          <a:srcRect l="0" t="12234" r="3840" b="37623"/>
          <a:stretch/>
        </p:blipFill>
        <p:spPr>
          <a:xfrm>
            <a:off x="317520" y="3882960"/>
            <a:ext cx="6265800" cy="1538280"/>
          </a:xfrm>
          <a:prstGeom prst="rect">
            <a:avLst/>
          </a:prstGeom>
          <a:ln w="19080">
            <a:solidFill>
              <a:srgbClr val="000000"/>
            </a:solidFill>
            <a:miter/>
          </a:ln>
        </p:spPr>
      </p:pic>
      <p:sp>
        <p:nvSpPr>
          <p:cNvPr id="55" name="ZoneTexte 5"/>
          <p:cNvSpPr/>
          <p:nvPr/>
        </p:nvSpPr>
        <p:spPr>
          <a:xfrm>
            <a:off x="173160" y="547056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285840" y="5784840"/>
          <a:ext cx="6343560" cy="3800520"/>
        </p:xfrm>
        <a:graphic>
          <a:graphicData uri="http://schemas.openxmlformats.org/drawingml/2006/table">
            <a:tbl>
              <a:tblPr/>
              <a:tblGrid>
                <a:gridCol w="1500120"/>
                <a:gridCol w="1779480"/>
                <a:gridCol w="1565280"/>
                <a:gridCol w="711360"/>
                <a:gridCol w="787320"/>
              </a:tblGrid>
              <a:tr h="247680"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Name of probesets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Primer Forward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Primer Rever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Tm experimen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Length amplicon experimental (pb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11052202-HERV1033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GCAGAAGAAGATGGATA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GAGCTGACATCATCCA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11052702-MALR1044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ACTGTTCACTGCTATCCT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TGTGGCAGCTTTTTGAAGT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11052902-MALR1126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CCCTTGATCTTGAAATTCC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CAGGTGGGGCTGCTA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43166701-MALR1020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CAGGACCTGCTAACTG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GAAGGTCACTTGTCTAG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70278702-MALR1045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TGCCTTTGTCTTGGA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TGCCATAACAAAATACCTTA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146702-MALR1129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TTGAAAAAAGACTTCACATT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TAAGCCACCAGACTTC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9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300702-MALR1002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TTACTCCCATGAGAATGG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TGTGGAATCTCATGGTGAAA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0866702-HERV0531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GGTTATCTGTGCTACA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ACGATGACCGAT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1601801-HERV0492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TCTAGGAATCTTAGG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AAACCAATAGTCCAG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1601802-HERV0492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ACCACAAACATCCAT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GGTCTGGCTGTAATTT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1601901-HERV0116uI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AGACCAATGCAGTTAGGTGG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GGCTGCAAGAAATGC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0554301-MALR1004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ATCATGACCCCCG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CAAGATCCTTTACTTAATCT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96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0554302-MALR1004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TGAAGCTCCCAGAA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ACCCCAAACATAGTG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0598201-MALR1002c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CAAGCCTCCTGTTGATAT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CTCTTGGAGAAACTCTCA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0665001-HERV0376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TACAAAACTCAAATGGTCT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TGACCAACTTAGATTTCCT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00951702-MALR1126c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CTGGATTTCCTGACCTA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GTCCCAACAAAATTCATATC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11215603ERVTsL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ACTAGGTGCAGGGGCTTTA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CAGTCTGCATCTCGG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41607303MR41sL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TCACGGTGCTGGTGAAAGT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CCATCCCAGACAGTTAGGC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2539003PBLAsLU3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TTAGGCCCCCAATAAACC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AGGTCTCAGTTATGCAGGC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6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082202HK063LRp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TTTCTACAGTCTTTCATATTTGTT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CCTGTGATAAATCAAGCAG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9d9d9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20145402-MALR1127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AACACCAGTCATATTGGAT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GCTTTGGAATGGGACTG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8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91606902-MALR1005c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AACCAACTCGCCAATAC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GGACCTGTGAGTATGTG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6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248101-MALR1126u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GCTGAATTCCATCCT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ACAGTCATATTGGATTAA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Rectangle 3"/>
          <p:cNvSpPr/>
          <p:nvPr/>
        </p:nvSpPr>
        <p:spPr>
          <a:xfrm>
            <a:off x="163440" y="250920"/>
            <a:ext cx="6573960" cy="2614680"/>
          </a:xfrm>
          <a:prstGeom prst="rect">
            <a:avLst/>
          </a:prstGeom>
          <a:noFill/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277920" y="631800"/>
          <a:ext cx="6343560" cy="2023920"/>
        </p:xfrm>
        <a:graphic>
          <a:graphicData uri="http://schemas.openxmlformats.org/drawingml/2006/table">
            <a:tbl>
              <a:tblPr/>
              <a:tblGrid>
                <a:gridCol w="1500120"/>
                <a:gridCol w="1779480"/>
                <a:gridCol w="1565280"/>
                <a:gridCol w="711360"/>
                <a:gridCol w="787320"/>
              </a:tblGrid>
              <a:tr h="247680"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Name of probesets 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Primer Forward 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Primer Reverse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Tm experimental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b0f0"/>
                          </a:solidFill>
                          <a:latin typeface="Calibri"/>
                        </a:rPr>
                        <a:t>Length amplicon experimental (pb)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X11930ERVWsL 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CCTTGCTGGAAAAGGTG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ACCTCGTGCATTGGCCTA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X11930ERVWsL U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TTATGGGTCGAGCTGAGCT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CAATTGGGAGCAGCA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01039-MALR0820cL 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TGAGAGATTCGCTCCCAT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TAGTTTGGATGTGTGTCCC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01039-MALR0820cL U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AGGCTATTCTTGCATTGCTATA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GTGTCAGCATTATGCTT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1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1467-MALR1129uL 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CCCATTGTGTATAATGCAC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GATTAACTTAACTGAATGTGGA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1467-MALR1129uL U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ACATTCCAAATGAGACTCC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TAAGCCACCAGACTTCATG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4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8408ERVWsL 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GAATTCCTAAGCCTAGCTGG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CTGTGCTCTCAGGCAATATA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8408ERVWsL U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GGAGCAGAGCTATCGCT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TGATTAGGACGAACCCGG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8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5527-HERV1036cL 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CTTGTCTGCTGCCATATGAGA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CAAGTTGACAGGGCCTCA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7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815527-HERV1036cL U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AAAATCTGCTGAGTAGATGTCCT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CCTCACCCAATCAGTTGAAG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904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23947-HERV1034uL U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ATGCGTCAACTTGACTGGGT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GTCTCGTCCAGAAAATCCTCA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2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  <a:tr h="147600"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0523947-HERV1034uL U5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TTCTTCAGACTCAGATTGCTCT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AATCAGGGTTCTCCAGAGAAACA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6°C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 lIns="3600" rIns="3600" tIns="3600" bIns="0" anchor="b">
                      <a:noAutofit/>
                    </a:bodyPr>
                    <a:p>
                      <a:pPr algn="ctr">
                        <a:tabLst>
                          <a:tab algn="l" pos="0"/>
                          <a:tab algn="l" pos="976320"/>
                          <a:tab algn="l" pos="1952640"/>
                          <a:tab algn="l" pos="2928960"/>
                          <a:tab algn="l" pos="3905280"/>
                          <a:tab algn="l" pos="4881600"/>
                          <a:tab algn="l" pos="5857920"/>
                          <a:tab algn="l" pos="6834240"/>
                          <a:tab algn="l" pos="7810560"/>
                          <a:tab algn="l" pos="8786880"/>
                          <a:tab algn="l" pos="9763200"/>
                          <a:tab algn="l" pos="10739520"/>
                        </a:tabLst>
                      </a:pPr>
                      <a:r>
                        <a:rPr b="1" lang="fr-FR" sz="8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0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3600" marR="36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  <p:sp>
        <p:nvSpPr>
          <p:cNvPr id="59" name="ZoneTexte 5"/>
          <p:cNvSpPr/>
          <p:nvPr/>
        </p:nvSpPr>
        <p:spPr>
          <a:xfrm>
            <a:off x="173160" y="258840"/>
            <a:ext cx="323640" cy="31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7560" rIns="97560" tIns="48960" bIns="4896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>
                <a:solidFill>
                  <a:srgbClr val="000000"/>
                </a:solidFill>
                <a:latin typeface="Calibri"/>
                <a:ea typeface="Arial"/>
              </a:rPr>
              <a:t>F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9-17T08:32:57Z</dcterms:created>
  <dc:creator>MOMMERT Marine</dc:creator>
  <dc:description/>
  <dc:language>en-US</dc:language>
  <cp:lastModifiedBy>MOMMERT Marine</cp:lastModifiedBy>
  <dcterms:modified xsi:type="dcterms:W3CDTF">2018-06-25T19:26:17Z</dcterms:modified>
  <cp:revision>21</cp:revision>
  <dc:subject/>
  <dc:title>Présentation PowerPoint</dc:title>
</cp:coreProperties>
</file>